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jpeg" ContentType="image/jpeg"/>
  <Override PartName="/ppt/media/image2.jpeg" ContentType="image/jpe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5C59A78-4A19-43A3-855C-F6210DE7D89E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BBDEE23-5521-4928-8798-E30F8CA5B3E0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2D216FB-0834-429E-9239-FC951CCD1F33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D688EC8-43B5-4F5D-A811-81612573C397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416602A-7BAD-4350-9DF8-5FFEDB8FE51A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176A371-032E-453B-A9C3-15B61618E984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7B87C91-24A3-4B4E-BD2D-34088106833C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BF1D465-C724-4EE3-AC14-BFF6D5AB4638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54B4157-AD43-46F8-824B-3D4432C1E58C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B210880-C387-47C5-A185-F932C3BE20C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0F3EE97-A365-490A-B664-00007E5CF7F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597F7D8-306F-402F-B04A-B86EADD6433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15A19FFA-700E-42C5-B151-5843110F4400}" type="slidenum">
              <a:rPr b="0" lang="zh-CN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image" Target="../media/image2.jpeg"/><Relationship Id="rId3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2463840" y="5157720"/>
            <a:ext cx="73980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10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(a)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"/>
          <p:cNvSpPr/>
          <p:nvPr/>
        </p:nvSpPr>
        <p:spPr>
          <a:xfrm>
            <a:off x="5364000" y="5504040"/>
            <a:ext cx="73980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10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(b)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"/>
          <p:cNvSpPr/>
          <p:nvPr/>
        </p:nvSpPr>
        <p:spPr>
          <a:xfrm>
            <a:off x="360360" y="5816160"/>
            <a:ext cx="8459640" cy="8931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spAutoFit/>
          </a:bodyPr>
          <a:p>
            <a:pPr>
              <a:lnSpc>
                <a:spcPct val="125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400" spc="-1" strike="noStrike">
                <a:solidFill>
                  <a:srgbClr val="000000"/>
                </a:solidFill>
                <a:latin typeface="Times New Roman"/>
              </a:rPr>
              <a:t>Supplemental Figure 3. Independent confirmation of microarray data using RT-PCR.</a:t>
            </a:r>
            <a:r>
              <a:rPr b="0" lang="zh-CN" sz="1400" spc="-1" strike="noStrike">
                <a:solidFill>
                  <a:srgbClr val="000000"/>
                </a:solidFill>
                <a:latin typeface="Times New Roman"/>
              </a:rPr>
              <a:t> Microarray data and RT-PCR results for 33 selected silkworm genes are shown. Four genes encoding eIF-3 subunit 4,eIF 3A subunit 5, eIF 4A and proteasome subunit were used as negative controls.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4" name="" descr=""/>
          <p:cNvPicPr/>
          <p:nvPr/>
        </p:nvPicPr>
        <p:blipFill>
          <a:blip r:embed="rId1"/>
          <a:srcRect l="0" t="7598" r="30560" b="7316"/>
          <a:stretch/>
        </p:blipFill>
        <p:spPr>
          <a:xfrm>
            <a:off x="1863720" y="46080"/>
            <a:ext cx="2276640" cy="4967280"/>
          </a:xfrm>
          <a:prstGeom prst="rect">
            <a:avLst/>
          </a:prstGeom>
          <a:ln w="0">
            <a:noFill/>
          </a:ln>
        </p:spPr>
      </p:pic>
      <p:pic>
        <p:nvPicPr>
          <p:cNvPr id="45" name="" descr=""/>
          <p:cNvPicPr/>
          <p:nvPr/>
        </p:nvPicPr>
        <p:blipFill>
          <a:blip r:embed="rId2"/>
          <a:srcRect l="12857" t="6210" r="7121" b="11616"/>
          <a:stretch/>
        </p:blipFill>
        <p:spPr>
          <a:xfrm>
            <a:off x="4570560" y="487440"/>
            <a:ext cx="3816360" cy="504972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28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7-02-17T15:55:49Z</dcterms:created>
  <dc:creator>番茄花园</dc:creator>
  <dc:description/>
  <dc:language>en-US</dc:language>
  <cp:lastModifiedBy>chengdj</cp:lastModifiedBy>
  <dcterms:modified xsi:type="dcterms:W3CDTF">2007-06-18T18:07:43Z</dcterms:modified>
  <cp:revision>12</cp:revision>
  <dc:subject/>
  <dc:title>幻灯片 1</dc:title>
</cp:coreProperties>
</file>